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936" y="4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BC44BF1-9D42-4FC1-9FFD-DDC5F86390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0D8CB2FE-E555-4A89-A114-E89DB32E46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87C553A-8598-46A4-A9AB-A7A2A896F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AD973-694C-4A92-A65E-A0999F87E306}" type="datetimeFigureOut">
              <a:rPr lang="ko-KR" altLang="en-US" smtClean="0"/>
              <a:t>2023-10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9D33A3A-EB9D-404A-8764-C9B2292D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7D205CF-DF3B-46D0-960E-2AC0DCBE6E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0A3E-2E52-49F7-A1DA-FACEC871EB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1585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BB00EA-560E-4404-8796-A1561EDEE2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497CE4B-D994-44AB-BA85-6AB1A771A3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63273C2-AF52-44E1-9A9B-C15F13BFA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AD973-694C-4A92-A65E-A0999F87E306}" type="datetimeFigureOut">
              <a:rPr lang="ko-KR" altLang="en-US" smtClean="0"/>
              <a:t>2023-10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2B96CAE-7176-42CF-84FB-2BEB61ED78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3560444-D2B0-4CE4-8F80-6BF27FF187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0A3E-2E52-49F7-A1DA-FACEC871EB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7624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0D9E135-5009-4361-B1E7-8DEB986931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8CEAE9C-CC21-4218-9722-A0633DE8D1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C5113A6-7F90-41DF-B4C1-5FAD60BB9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AD973-694C-4A92-A65E-A0999F87E306}" type="datetimeFigureOut">
              <a:rPr lang="ko-KR" altLang="en-US" smtClean="0"/>
              <a:t>2023-10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66A88C0-2696-4A13-AF11-839527C70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9A56D74-36D4-4735-BA7F-0BD2277A2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0A3E-2E52-49F7-A1DA-FACEC871EB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4023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26F63EC-0881-4A96-8BE4-61B1972F31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F12686B-707F-4498-83C4-D1813D027A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181B407-EBC6-4EAB-B266-13D25FDFA9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AD973-694C-4A92-A65E-A0999F87E306}" type="datetimeFigureOut">
              <a:rPr lang="ko-KR" altLang="en-US" smtClean="0"/>
              <a:t>2023-10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0801AD6-AAB4-4F7B-9EF2-B30BD4D9FC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D11029E-35A7-49BB-ACDD-74C3833BB0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0A3E-2E52-49F7-A1DA-FACEC871EB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14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0334A27-8AFB-431E-88E1-C37E21365B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3EDDDEB-B628-41E4-8F07-55861AC1E7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7D2554B-11A0-48EE-9F25-100B06B7A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AD973-694C-4A92-A65E-A0999F87E306}" type="datetimeFigureOut">
              <a:rPr lang="ko-KR" altLang="en-US" smtClean="0"/>
              <a:t>2023-10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409EF0F-A6AA-4B7D-B7F2-E3C272BFD6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22FE46E-4F38-4C52-86D4-5983F894A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0A3E-2E52-49F7-A1DA-FACEC871EB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5374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3C6CCB8-D5CA-4127-AC35-802FCCEF8A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1528992-2A29-4628-BE64-26411BE7D4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BE97693-84F9-4C46-A011-53E6C5AC77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C9D1479-70C7-466A-A539-D6BAA32D2C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AD973-694C-4A92-A65E-A0999F87E306}" type="datetimeFigureOut">
              <a:rPr lang="ko-KR" altLang="en-US" smtClean="0"/>
              <a:t>2023-10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77D6536-65CD-434C-8F6B-6B7A0F767F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97E31A7-9676-4312-AD44-C29DCB61C0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0A3E-2E52-49F7-A1DA-FACEC871EB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97947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C9671AC-192A-42EE-B7E8-BA024EC067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6247334-4F67-4D81-9633-02F2ADA115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E1CAB48-F0B4-41C1-9EBF-5D670C9D9A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D9ED439-8C3F-4AE0-BC3F-21E1B8D502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3EE6EC6C-CB6C-4DA3-9931-38C2A3C029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FA9F435F-A824-4127-AA85-BC4F0E84C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AD973-694C-4A92-A65E-A0999F87E306}" type="datetimeFigureOut">
              <a:rPr lang="ko-KR" altLang="en-US" smtClean="0"/>
              <a:t>2023-10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1E44165-31A9-4F11-85AB-3A0E9E237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42950254-824F-4D73-A9AB-94734E8AB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0A3E-2E52-49F7-A1DA-FACEC871EB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7922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F937E74-F7FE-44A9-8485-FC359610AB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AB8D771C-23BE-4B0F-9924-43197BFD9F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AD973-694C-4A92-A65E-A0999F87E306}" type="datetimeFigureOut">
              <a:rPr lang="ko-KR" altLang="en-US" smtClean="0"/>
              <a:t>2023-10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83E5CD5-B9C0-4F6C-9861-C76DCDE27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C0068C78-6AE6-4AAC-BA2F-6862A3523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0A3E-2E52-49F7-A1DA-FACEC871EB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5970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CE341537-DF8E-43A7-82AD-0B4849DCA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AD973-694C-4A92-A65E-A0999F87E306}" type="datetimeFigureOut">
              <a:rPr lang="ko-KR" altLang="en-US" smtClean="0"/>
              <a:t>2023-10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00771E11-0B2A-4E59-A1CC-4B7C56F14B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CD2C0600-877A-471F-99C6-437A20957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0A3E-2E52-49F7-A1DA-FACEC871EB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2859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94CBD3-52D2-424E-B8AE-1BFC4DA54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BC1B87D-979E-49EA-933A-BF12EE87FB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FD2BA77-F5B4-4569-B29E-81BF8DA8C2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68D029A-C5E5-4442-81EC-E822DA30A7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AD973-694C-4A92-A65E-A0999F87E306}" type="datetimeFigureOut">
              <a:rPr lang="ko-KR" altLang="en-US" smtClean="0"/>
              <a:t>2023-10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2EC24D3-99A6-4BBB-9296-2ECAAF77FC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FFB21D8-DDC8-43BA-9170-455A68B82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0A3E-2E52-49F7-A1DA-FACEC871EB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2072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6421FC3-6AFF-411F-826B-16BD8181A6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7A9A0B3D-D564-4EB0-866E-E2D3950FF2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35AA08E-74EA-4687-B112-8E2EF6BEC5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45D8BBF-96E6-4DB5-9EB4-934319D84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AD973-694C-4A92-A65E-A0999F87E306}" type="datetimeFigureOut">
              <a:rPr lang="ko-KR" altLang="en-US" smtClean="0"/>
              <a:t>2023-10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6B6E230-DA3E-4569-9994-8BEC53788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22E0457-1BD4-472B-B709-1A2E0EB07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0A3E-2E52-49F7-A1DA-FACEC871EB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6936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9FBD9C41-0151-4C40-9AA7-02B565883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B5BFD80-1997-4F17-8A17-88C863191B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FD18AD6-9872-4C1A-8CE4-76FDCDDFB2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AD973-694C-4A92-A65E-A0999F87E306}" type="datetimeFigureOut">
              <a:rPr lang="ko-KR" altLang="en-US" smtClean="0"/>
              <a:t>2023-10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D6B9FD5-AC71-438E-8D28-F17E3A3B5E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A6B0291-0CC7-4B20-87F0-0BBB668F15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C00A3E-2E52-49F7-A1DA-FACEC871EB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3165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2211D473-FA12-4600-A818-C1A2E6FAC2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576" y="192095"/>
            <a:ext cx="5854999" cy="4680000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3D7DC827-C26C-4D6E-A889-6F4F2501B881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281250" y="192095"/>
            <a:ext cx="5853600" cy="4680000"/>
          </a:xfrm>
          <a:prstGeom prst="rect">
            <a:avLst/>
          </a:prstGeom>
        </p:spPr>
      </p:pic>
      <p:sp>
        <p:nvSpPr>
          <p:cNvPr id="8" name="직사각형 7">
            <a:extLst>
              <a:ext uri="{FF2B5EF4-FFF2-40B4-BE49-F238E27FC236}">
                <a16:creationId xmlns:a16="http://schemas.microsoft.com/office/drawing/2014/main" id="{C61DFA45-4AEA-4189-A72C-7000C7AE94F4}"/>
              </a:ext>
            </a:extLst>
          </p:cNvPr>
          <p:cNvSpPr/>
          <p:nvPr/>
        </p:nvSpPr>
        <p:spPr>
          <a:xfrm>
            <a:off x="2819090" y="5083244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</a:t>
            </a:r>
            <a:endParaRPr lang="ko-KR" altLang="en-US" dirty="0"/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07BF1ABA-51F9-493C-8D52-849C965C33ED}"/>
              </a:ext>
            </a:extLst>
          </p:cNvPr>
          <p:cNvSpPr/>
          <p:nvPr/>
        </p:nvSpPr>
        <p:spPr>
          <a:xfrm>
            <a:off x="8974653" y="5083244"/>
            <a:ext cx="4667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b)</a:t>
            </a:r>
            <a:endParaRPr lang="ko-KR" altLang="en-US" dirty="0"/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991F12C1-125D-46E0-8738-356CE9EAB954}"/>
              </a:ext>
            </a:extLst>
          </p:cNvPr>
          <p:cNvSpPr/>
          <p:nvPr/>
        </p:nvSpPr>
        <p:spPr>
          <a:xfrm>
            <a:off x="1954024" y="5568475"/>
            <a:ext cx="9190225" cy="11449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ko-KR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altLang="ko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EGG Analysis of predicted target genes regulated by </a:t>
            </a:r>
            <a:r>
              <a:rPr lang="en-US" altLang="ko-KR" i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caca</a:t>
            </a:r>
            <a:r>
              <a:rPr lang="en-US" altLang="ko-KR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ulatta</a:t>
            </a:r>
            <a:r>
              <a:rPr lang="en-US" altLang="ko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DTEs. Circle color means -log10(FDR) and the circle size indicates the number of genes. (a) mml-miR-7163-5p (FDR cutoff 0.054); (b) mml-miR-7174-5p (FDR cutoff</a:t>
            </a:r>
            <a:r>
              <a:rPr lang="en-US" altLang="ko-KR" baseline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0.051</a:t>
            </a:r>
            <a:r>
              <a:rPr lang="en-US" altLang="ko-K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657522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58</Words>
  <Application>Microsoft Office PowerPoint</Application>
  <PresentationFormat>와이드스크린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SimSun</vt:lpstr>
      <vt:lpstr>맑은 고딕</vt:lpstr>
      <vt:lpstr>Arial</vt:lpstr>
      <vt:lpstr>Palatino Linotype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윤주</dc:creator>
  <cp:lastModifiedBy>이윤주</cp:lastModifiedBy>
  <cp:revision>4</cp:revision>
  <dcterms:created xsi:type="dcterms:W3CDTF">2023-10-08T08:37:27Z</dcterms:created>
  <dcterms:modified xsi:type="dcterms:W3CDTF">2023-10-08T08:54:05Z</dcterms:modified>
</cp:coreProperties>
</file>